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5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F21BC-31B0-3E91-1C74-BAEF61057C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3E543E-0486-2ADF-CF90-E27907D519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8C2C32-2B92-9D0E-9F35-22FE50013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3C4AA-2E3D-D940-2657-2E86D6A46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22791-D442-DB04-A6F5-22F4D5EAF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26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AEFDE-E3C1-4B01-CC6B-148E37406C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011008-570C-2F23-DA10-A787F967FF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F3354-2808-1ABE-9FF6-4FED12850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BEE636-4709-2757-04ED-5A70F530F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28681F-93F5-81EC-97BA-816C9C3B8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131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D2751F-00BC-3356-59C9-70BAE74DCB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130C09-34FA-3A4D-63F3-A7CF0868B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047C5F-E920-EEFA-48A8-0ED317175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3DFA04-2D65-89DA-DBB6-F1E50C695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2A6C2-AE2F-2CDA-2717-5984BC7D1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9483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2649B-277F-AE74-0A1A-E78C32DC5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C51A7E-78EF-EF5B-39BD-42C8FE0E02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47803D-5777-1FD8-E398-295AC85BF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7F50E-87A8-A935-DA7B-7E4ACF1FD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FEAF8E-9371-5226-425F-90B0C4119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2327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40379-F2C0-FA7F-964C-4FCFD0481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6CD4BD-8EDC-25D0-25E4-E6E7275AE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013F61-6B0D-1A95-642D-DF9095998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44554-0C6D-3C69-4ABA-E4AB4372B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A310CB-256C-D092-0EEB-90E523871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915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57F0D-0997-DC43-4854-DD5BC8AF04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18C46-416A-6577-B8D4-C1B6930F69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BDBFEA-8BD8-3516-F951-012F0FCF66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226428-3ED2-EDA7-EBC2-6CB8D165B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A24356-418D-574C-7AFA-0DCB050AF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B7A490-6998-A0B3-63CF-B8E0DD69E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861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E1D782-03A7-D5E1-C335-A6E4283D4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A71B15-C7A7-9493-0A43-B625CFEDB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676D5E-5297-3F33-5303-69C6AFE03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91D87F-D314-DA5B-A655-43F9BF9C88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70729F-08DF-BB66-4084-D0A3254459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AF9470-A42F-1267-89F8-314FCD089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9209A7-8277-AF30-D85B-51133CEA1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0CFA6A-090F-D2B0-D502-A7B26F313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6304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87BBA3-13E0-300E-8301-71BCEFDAD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018186-1884-5CD9-2D8A-F3B345B1E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F10DDF-0022-B00B-2C0F-5013F726B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26A8EE-BD84-5D28-179B-2E938B311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268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62022C-F3C5-4674-6A59-67AA5927C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6E6C40-8321-32BE-EAF0-EBFC78959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AE2AF8-7A8C-1B31-2FB2-EF61DA7E0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583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99F5A-7BC5-AFBA-60B1-D380ABB45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520F54-FC38-048F-4E94-1621E36D29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6D4C92-EA36-175A-D608-71A1B7CE38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B438B8-F71C-0D00-A0D3-D689B751E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2E9AB7-C961-FFB5-9313-ADBA9E25A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DD9F6D-9BF0-DAAF-827C-98C1D99CB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272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6635F6-BF57-05A7-6A94-B9D6C1F1E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41BD03-101B-6C36-EDE1-0A27FBEE22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6897C6-71F0-4039-6114-4419840DB9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40BE88-C99B-3F68-95CF-EBB74B103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98C54A-EB33-5178-5958-7256EB065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66A4E0-891A-F10A-B550-B1E7EFA6B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67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CCA995-5F86-D8F8-C02C-0C41117A4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78AAF5-8382-9F19-7D18-3EE694F7CD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FFA5B2-1979-646E-5081-818DCEA464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F8EC7-C49E-4492-9934-BAA31CD10555}" type="datetimeFigureOut">
              <a:rPr lang="en-GB" smtClean="0"/>
              <a:t>1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1C775-F41E-A22C-67D5-01D262D251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91F678-A464-4801-9E38-0A3151D3D8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CAE65B-E523-4AF4-B758-E9971118A8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580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video" Target="NULL" TargetMode="External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microsoft.com/office/2007/relationships/media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9EFDEAE9-9C7A-1BDD-3D92-90F736577E9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896702" y="2486816"/>
            <a:ext cx="2991724" cy="2916457"/>
          </a:xfrm>
          <a:prstGeom prst="rect">
            <a:avLst/>
          </a:prstGeom>
        </p:spPr>
      </p:pic>
      <p:pic>
        <p:nvPicPr>
          <p:cNvPr id="10" name="Screen Recording 7">
            <a:hlinkClick r:id="" action="ppaction://media"/>
            <a:extLst>
              <a:ext uri="{FF2B5EF4-FFF2-40B4-BE49-F238E27FC236}">
                <a16:creationId xmlns:a16="http://schemas.microsoft.com/office/drawing/2014/main" id="{00F1CBE6-05B5-64DD-79FD-ED9C0D1873B3}"/>
              </a:ext>
            </a:extLst>
          </p:cNvPr>
          <p:cNvPicPr>
            <a:picLocks noGrp="1" noChangeAspect="1"/>
          </p:cNvPicPr>
          <p:nvPr>
            <p:ph sz="quarter" idx="4"/>
            <a:videoFile r:link="rId3"/>
            <p:extLst>
              <p:ext uri="{DAA4B4D4-6D71-4841-9C94-3DE7FCFB9230}">
                <p14:media xmlns:p14="http://schemas.microsoft.com/office/powerpoint/2010/main" r:embed="rId4">
                  <p14:trim end="1853.8571"/>
                </p14:media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236728" y="2486815"/>
            <a:ext cx="3169557" cy="2916458"/>
          </a:xfrm>
        </p:spPr>
      </p:pic>
      <p:pic>
        <p:nvPicPr>
          <p:cNvPr id="2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86E58F61-1633-8228-ADF5-A7D2230B84F4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rcRect l="9010" t="13676" r="10826" b="12623"/>
          <a:stretch>
            <a:fillRect/>
          </a:stretch>
        </p:blipFill>
        <p:spPr>
          <a:xfrm>
            <a:off x="7754587" y="2486815"/>
            <a:ext cx="3169557" cy="29164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4901CF9-E7E5-650F-32E0-932C4326CFC3}"/>
              </a:ext>
            </a:extLst>
          </p:cNvPr>
          <p:cNvSpPr txBox="1"/>
          <p:nvPr/>
        </p:nvSpPr>
        <p:spPr>
          <a:xfrm>
            <a:off x="836612" y="854561"/>
            <a:ext cx="122849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Video 3: 1</a:t>
            </a:r>
            <a:r>
              <a:rPr lang="en-GB" baseline="30000" dirty="0"/>
              <a:t>st</a:t>
            </a:r>
            <a:r>
              <a:rPr lang="en-GB" dirty="0"/>
              <a:t> pane showing initial deployment and popping up of TAVI valve into the aorta. 2</a:t>
            </a:r>
            <a:r>
              <a:rPr lang="en-GB" baseline="30000" dirty="0"/>
              <a:t>nd</a:t>
            </a:r>
            <a:r>
              <a:rPr lang="en-GB" dirty="0"/>
              <a:t> pane showing at the second attempt, the valve was deployed to a lower position, at the anastomosis between native LVOT and autograft. 3</a:t>
            </a:r>
            <a:r>
              <a:rPr lang="en-GB" baseline="30000" dirty="0"/>
              <a:t>rd</a:t>
            </a:r>
            <a:r>
              <a:rPr lang="en-GB" dirty="0"/>
              <a:t> pane showing final deployment position in relation to the neo aortic valve.</a:t>
            </a:r>
            <a:endParaRPr lang="en-IN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26185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28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314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784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seq concurrent="1" nextAc="seek">
              <p:cTn id="21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2" fill="hold">
                      <p:stCondLst>
                        <p:cond delay="0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5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26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2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8" fill="hold">
                      <p:stCondLst>
                        <p:cond delay="0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3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58</Words>
  <Application>Microsoft Macintosh PowerPoint</Application>
  <PresentationFormat>Widescreen</PresentationFormat>
  <Paragraphs>1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KHERJEE, Anindya (YORK AND SCARBOROUGH TEACHING HOSPITALS NHS FOUNDATION TRUST)</dc:creator>
  <cp:lastModifiedBy>Anindya Mukherjee</cp:lastModifiedBy>
  <cp:revision>8</cp:revision>
  <dcterms:created xsi:type="dcterms:W3CDTF">2025-05-18T07:29:52Z</dcterms:created>
  <dcterms:modified xsi:type="dcterms:W3CDTF">2025-05-18T15:38:31Z</dcterms:modified>
</cp:coreProperties>
</file>